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295" r:id="rId2"/>
  </p:sldIdLst>
  <p:sldSz cx="7315200" cy="100584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5064" userDrawn="1">
          <p15:clr>
            <a:srgbClr val="A4A3A4"/>
          </p15:clr>
        </p15:guide>
        <p15:guide id="2" pos="4224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1600FF"/>
    <a:srgbClr val="A5FF6B"/>
    <a:srgbClr val="FF9231"/>
    <a:srgbClr val="EA003F"/>
    <a:srgbClr val="E13AFE"/>
    <a:srgbClr val="DB9700"/>
    <a:srgbClr val="00F2A1"/>
    <a:srgbClr val="00907C"/>
    <a:srgbClr val="4A4FC5"/>
    <a:srgbClr val="E90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6395"/>
    <p:restoredTop sz="94694"/>
  </p:normalViewPr>
  <p:slideViewPr>
    <p:cSldViewPr snapToGrid="0" snapToObjects="1">
      <p:cViewPr varScale="1">
        <p:scale>
          <a:sx n="82" d="100"/>
          <a:sy n="82" d="100"/>
        </p:scale>
        <p:origin x="4080" y="192"/>
      </p:cViewPr>
      <p:guideLst>
        <p:guide orient="horz" pos="5064"/>
        <p:guide pos="4224"/>
      </p:guideLst>
    </p:cSldViewPr>
  </p:slideViewPr>
  <p:notesTextViewPr>
    <p:cViewPr>
      <p:scale>
        <a:sx n="85" d="100"/>
        <a:sy n="85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10D109F-9FEC-DA44-A69C-E029EAED4A05}" type="datetimeFigureOut">
              <a:rPr lang="en-US" smtClean="0"/>
              <a:t>4/29/21</a:t>
            </a:fld>
            <a:endParaRPr lang="en-US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06638" y="1143000"/>
            <a:ext cx="22447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761CA8D-B548-7247-B2E9-BB70CA9702F1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57320291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48640" y="1646133"/>
            <a:ext cx="6217920" cy="3501813"/>
          </a:xfrm>
        </p:spPr>
        <p:txBody>
          <a:bodyPr anchor="b"/>
          <a:lstStyle>
            <a:lvl1pPr algn="ctr">
              <a:defRPr sz="48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14400" y="5282989"/>
            <a:ext cx="5486400" cy="2428451"/>
          </a:xfrm>
        </p:spPr>
        <p:txBody>
          <a:bodyPr/>
          <a:lstStyle>
            <a:lvl1pPr marL="0" indent="0" algn="ctr">
              <a:buNone/>
              <a:defRPr sz="1920"/>
            </a:lvl1pPr>
            <a:lvl2pPr marL="365760" indent="0" algn="ctr">
              <a:buNone/>
              <a:defRPr sz="1600"/>
            </a:lvl2pPr>
            <a:lvl3pPr marL="731520" indent="0" algn="ctr">
              <a:buNone/>
              <a:defRPr sz="1440"/>
            </a:lvl3pPr>
            <a:lvl4pPr marL="1097280" indent="0" algn="ctr">
              <a:buNone/>
              <a:defRPr sz="1280"/>
            </a:lvl4pPr>
            <a:lvl5pPr marL="1463040" indent="0" algn="ctr">
              <a:buNone/>
              <a:defRPr sz="1280"/>
            </a:lvl5pPr>
            <a:lvl6pPr marL="1828800" indent="0" algn="ctr">
              <a:buNone/>
              <a:defRPr sz="1280"/>
            </a:lvl6pPr>
            <a:lvl7pPr marL="2194560" indent="0" algn="ctr">
              <a:buNone/>
              <a:defRPr sz="1280"/>
            </a:lvl7pPr>
            <a:lvl8pPr marL="2560320" indent="0" algn="ctr">
              <a:buNone/>
              <a:defRPr sz="1280"/>
            </a:lvl8pPr>
            <a:lvl9pPr marL="2926080" indent="0" algn="ctr">
              <a:buNone/>
              <a:defRPr sz="128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C5123D-F290-C341-8654-3BA8AF323E09}" type="datetimeFigureOut">
              <a:rPr lang="en-US" smtClean="0"/>
              <a:t>4/29/21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86DEE3-3E10-504B-A4A6-7668CE917EF5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06276237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C5123D-F290-C341-8654-3BA8AF323E09}" type="datetimeFigureOut">
              <a:rPr lang="en-US" smtClean="0"/>
              <a:t>4/29/21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86DEE3-3E10-504B-A4A6-7668CE917EF5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20431380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234940" y="535517"/>
            <a:ext cx="1577340" cy="852402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02920" y="535517"/>
            <a:ext cx="4640580" cy="8524029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C5123D-F290-C341-8654-3BA8AF323E09}" type="datetimeFigureOut">
              <a:rPr lang="en-US" smtClean="0"/>
              <a:t>4/29/21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86DEE3-3E10-504B-A4A6-7668CE917EF5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70735560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C5123D-F290-C341-8654-3BA8AF323E09}" type="datetimeFigureOut">
              <a:rPr lang="en-US" smtClean="0"/>
              <a:t>4/29/21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86DEE3-3E10-504B-A4A6-7668CE917EF5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13961377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9110" y="2507618"/>
            <a:ext cx="6309360" cy="4184014"/>
          </a:xfrm>
        </p:spPr>
        <p:txBody>
          <a:bodyPr anchor="b"/>
          <a:lstStyle>
            <a:lvl1pPr>
              <a:defRPr sz="48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99110" y="6731215"/>
            <a:ext cx="6309360" cy="2200274"/>
          </a:xfrm>
        </p:spPr>
        <p:txBody>
          <a:bodyPr/>
          <a:lstStyle>
            <a:lvl1pPr marL="0" indent="0">
              <a:buNone/>
              <a:defRPr sz="1920">
                <a:solidFill>
                  <a:schemeClr val="tx1"/>
                </a:solidFill>
              </a:defRPr>
            </a:lvl1pPr>
            <a:lvl2pPr marL="36576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2pPr>
            <a:lvl3pPr marL="731520" indent="0">
              <a:buNone/>
              <a:defRPr sz="1440">
                <a:solidFill>
                  <a:schemeClr val="tx1">
                    <a:tint val="75000"/>
                  </a:schemeClr>
                </a:solidFill>
              </a:defRPr>
            </a:lvl3pPr>
            <a:lvl4pPr marL="109728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4pPr>
            <a:lvl5pPr marL="146304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5pPr>
            <a:lvl6pPr marL="182880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6pPr>
            <a:lvl7pPr marL="219456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7pPr>
            <a:lvl8pPr marL="256032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8pPr>
            <a:lvl9pPr marL="292608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C5123D-F290-C341-8654-3BA8AF323E09}" type="datetimeFigureOut">
              <a:rPr lang="en-US" smtClean="0"/>
              <a:t>4/29/21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86DEE3-3E10-504B-A4A6-7668CE917EF5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24821083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02920" y="2677584"/>
            <a:ext cx="310896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703320" y="2677584"/>
            <a:ext cx="310896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C5123D-F290-C341-8654-3BA8AF323E09}" type="datetimeFigureOut">
              <a:rPr lang="en-US" smtClean="0"/>
              <a:t>4/29/21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86DEE3-3E10-504B-A4A6-7668CE917EF5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73056354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03873" y="535519"/>
            <a:ext cx="6309360" cy="1944159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03874" y="2465706"/>
            <a:ext cx="3094672" cy="1208404"/>
          </a:xfrm>
        </p:spPr>
        <p:txBody>
          <a:bodyPr anchor="b"/>
          <a:lstStyle>
            <a:lvl1pPr marL="0" indent="0">
              <a:buNone/>
              <a:defRPr sz="1920" b="1"/>
            </a:lvl1pPr>
            <a:lvl2pPr marL="365760" indent="0">
              <a:buNone/>
              <a:defRPr sz="1600" b="1"/>
            </a:lvl2pPr>
            <a:lvl3pPr marL="731520" indent="0">
              <a:buNone/>
              <a:defRPr sz="1440" b="1"/>
            </a:lvl3pPr>
            <a:lvl4pPr marL="1097280" indent="0">
              <a:buNone/>
              <a:defRPr sz="1280" b="1"/>
            </a:lvl4pPr>
            <a:lvl5pPr marL="1463040" indent="0">
              <a:buNone/>
              <a:defRPr sz="1280" b="1"/>
            </a:lvl5pPr>
            <a:lvl6pPr marL="1828800" indent="0">
              <a:buNone/>
              <a:defRPr sz="1280" b="1"/>
            </a:lvl6pPr>
            <a:lvl7pPr marL="2194560" indent="0">
              <a:buNone/>
              <a:defRPr sz="1280" b="1"/>
            </a:lvl7pPr>
            <a:lvl8pPr marL="2560320" indent="0">
              <a:buNone/>
              <a:defRPr sz="1280" b="1"/>
            </a:lvl8pPr>
            <a:lvl9pPr marL="2926080" indent="0">
              <a:buNone/>
              <a:defRPr sz="128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3874" y="3674110"/>
            <a:ext cx="3094672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703320" y="2465706"/>
            <a:ext cx="3109913" cy="1208404"/>
          </a:xfrm>
        </p:spPr>
        <p:txBody>
          <a:bodyPr anchor="b"/>
          <a:lstStyle>
            <a:lvl1pPr marL="0" indent="0">
              <a:buNone/>
              <a:defRPr sz="1920" b="1"/>
            </a:lvl1pPr>
            <a:lvl2pPr marL="365760" indent="0">
              <a:buNone/>
              <a:defRPr sz="1600" b="1"/>
            </a:lvl2pPr>
            <a:lvl3pPr marL="731520" indent="0">
              <a:buNone/>
              <a:defRPr sz="1440" b="1"/>
            </a:lvl3pPr>
            <a:lvl4pPr marL="1097280" indent="0">
              <a:buNone/>
              <a:defRPr sz="1280" b="1"/>
            </a:lvl4pPr>
            <a:lvl5pPr marL="1463040" indent="0">
              <a:buNone/>
              <a:defRPr sz="1280" b="1"/>
            </a:lvl5pPr>
            <a:lvl6pPr marL="1828800" indent="0">
              <a:buNone/>
              <a:defRPr sz="1280" b="1"/>
            </a:lvl6pPr>
            <a:lvl7pPr marL="2194560" indent="0">
              <a:buNone/>
              <a:defRPr sz="1280" b="1"/>
            </a:lvl7pPr>
            <a:lvl8pPr marL="2560320" indent="0">
              <a:buNone/>
              <a:defRPr sz="1280" b="1"/>
            </a:lvl8pPr>
            <a:lvl9pPr marL="2926080" indent="0">
              <a:buNone/>
              <a:defRPr sz="128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703320" y="3674110"/>
            <a:ext cx="3109913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C5123D-F290-C341-8654-3BA8AF323E09}" type="datetimeFigureOut">
              <a:rPr lang="en-US" smtClean="0"/>
              <a:t>4/29/21</a:t>
            </a:fld>
            <a:endParaRPr lang="en-US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86DEE3-3E10-504B-A4A6-7668CE917EF5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11057111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C5123D-F290-C341-8654-3BA8AF323E09}" type="datetimeFigureOut">
              <a:rPr lang="en-US" smtClean="0"/>
              <a:t>4/29/21</a:t>
            </a:fld>
            <a:endParaRPr 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86DEE3-3E10-504B-A4A6-7668CE917EF5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89929439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C5123D-F290-C341-8654-3BA8AF323E09}" type="datetimeFigureOut">
              <a:rPr lang="en-US" smtClean="0"/>
              <a:t>4/29/21</a:t>
            </a:fld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86DEE3-3E10-504B-A4A6-7668CE917EF5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12236924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03873" y="670560"/>
            <a:ext cx="2359342" cy="2346960"/>
          </a:xfrm>
        </p:spPr>
        <p:txBody>
          <a:bodyPr anchor="b"/>
          <a:lstStyle>
            <a:lvl1pPr>
              <a:defRPr sz="256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109913" y="1448226"/>
            <a:ext cx="3703320" cy="7147983"/>
          </a:xfrm>
        </p:spPr>
        <p:txBody>
          <a:bodyPr/>
          <a:lstStyle>
            <a:lvl1pPr>
              <a:defRPr sz="2560"/>
            </a:lvl1pPr>
            <a:lvl2pPr>
              <a:defRPr sz="2240"/>
            </a:lvl2pPr>
            <a:lvl3pPr>
              <a:defRPr sz="192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03873" y="3017520"/>
            <a:ext cx="2359342" cy="5590329"/>
          </a:xfrm>
        </p:spPr>
        <p:txBody>
          <a:bodyPr/>
          <a:lstStyle>
            <a:lvl1pPr marL="0" indent="0">
              <a:buNone/>
              <a:defRPr sz="1280"/>
            </a:lvl1pPr>
            <a:lvl2pPr marL="365760" indent="0">
              <a:buNone/>
              <a:defRPr sz="1120"/>
            </a:lvl2pPr>
            <a:lvl3pPr marL="731520" indent="0">
              <a:buNone/>
              <a:defRPr sz="960"/>
            </a:lvl3pPr>
            <a:lvl4pPr marL="1097280" indent="0">
              <a:buNone/>
              <a:defRPr sz="800"/>
            </a:lvl4pPr>
            <a:lvl5pPr marL="1463040" indent="0">
              <a:buNone/>
              <a:defRPr sz="800"/>
            </a:lvl5pPr>
            <a:lvl6pPr marL="1828800" indent="0">
              <a:buNone/>
              <a:defRPr sz="800"/>
            </a:lvl6pPr>
            <a:lvl7pPr marL="2194560" indent="0">
              <a:buNone/>
              <a:defRPr sz="800"/>
            </a:lvl7pPr>
            <a:lvl8pPr marL="2560320" indent="0">
              <a:buNone/>
              <a:defRPr sz="800"/>
            </a:lvl8pPr>
            <a:lvl9pPr marL="2926080" indent="0">
              <a:buNone/>
              <a:defRPr sz="8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C5123D-F290-C341-8654-3BA8AF323E09}" type="datetimeFigureOut">
              <a:rPr lang="en-US" smtClean="0"/>
              <a:t>4/29/21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86DEE3-3E10-504B-A4A6-7668CE917EF5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78958433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03873" y="670560"/>
            <a:ext cx="2359342" cy="2346960"/>
          </a:xfrm>
        </p:spPr>
        <p:txBody>
          <a:bodyPr anchor="b"/>
          <a:lstStyle>
            <a:lvl1pPr>
              <a:defRPr sz="256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109913" y="1448226"/>
            <a:ext cx="3703320" cy="7147983"/>
          </a:xfrm>
        </p:spPr>
        <p:txBody>
          <a:bodyPr anchor="t"/>
          <a:lstStyle>
            <a:lvl1pPr marL="0" indent="0">
              <a:buNone/>
              <a:defRPr sz="2560"/>
            </a:lvl1pPr>
            <a:lvl2pPr marL="365760" indent="0">
              <a:buNone/>
              <a:defRPr sz="2240"/>
            </a:lvl2pPr>
            <a:lvl3pPr marL="731520" indent="0">
              <a:buNone/>
              <a:defRPr sz="1920"/>
            </a:lvl3pPr>
            <a:lvl4pPr marL="1097280" indent="0">
              <a:buNone/>
              <a:defRPr sz="1600"/>
            </a:lvl4pPr>
            <a:lvl5pPr marL="1463040" indent="0">
              <a:buNone/>
              <a:defRPr sz="1600"/>
            </a:lvl5pPr>
            <a:lvl6pPr marL="1828800" indent="0">
              <a:buNone/>
              <a:defRPr sz="1600"/>
            </a:lvl6pPr>
            <a:lvl7pPr marL="2194560" indent="0">
              <a:buNone/>
              <a:defRPr sz="1600"/>
            </a:lvl7pPr>
            <a:lvl8pPr marL="2560320" indent="0">
              <a:buNone/>
              <a:defRPr sz="1600"/>
            </a:lvl8pPr>
            <a:lvl9pPr marL="2926080" indent="0">
              <a:buNone/>
              <a:defRPr sz="1600"/>
            </a:lvl9pPr>
          </a:lstStyle>
          <a:p>
            <a:r>
              <a:rPr lang="en-US" dirty="0"/>
              <a:t>Click icon to add picture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03873" y="3017520"/>
            <a:ext cx="2359342" cy="5590329"/>
          </a:xfrm>
        </p:spPr>
        <p:txBody>
          <a:bodyPr/>
          <a:lstStyle>
            <a:lvl1pPr marL="0" indent="0">
              <a:buNone/>
              <a:defRPr sz="1280"/>
            </a:lvl1pPr>
            <a:lvl2pPr marL="365760" indent="0">
              <a:buNone/>
              <a:defRPr sz="1120"/>
            </a:lvl2pPr>
            <a:lvl3pPr marL="731520" indent="0">
              <a:buNone/>
              <a:defRPr sz="960"/>
            </a:lvl3pPr>
            <a:lvl4pPr marL="1097280" indent="0">
              <a:buNone/>
              <a:defRPr sz="800"/>
            </a:lvl4pPr>
            <a:lvl5pPr marL="1463040" indent="0">
              <a:buNone/>
              <a:defRPr sz="800"/>
            </a:lvl5pPr>
            <a:lvl6pPr marL="1828800" indent="0">
              <a:buNone/>
              <a:defRPr sz="800"/>
            </a:lvl6pPr>
            <a:lvl7pPr marL="2194560" indent="0">
              <a:buNone/>
              <a:defRPr sz="800"/>
            </a:lvl7pPr>
            <a:lvl8pPr marL="2560320" indent="0">
              <a:buNone/>
              <a:defRPr sz="800"/>
            </a:lvl8pPr>
            <a:lvl9pPr marL="2926080" indent="0">
              <a:buNone/>
              <a:defRPr sz="8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C5123D-F290-C341-8654-3BA8AF323E09}" type="datetimeFigureOut">
              <a:rPr lang="en-US" smtClean="0"/>
              <a:t>4/29/21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86DEE3-3E10-504B-A4A6-7668CE917EF5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48188131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02920" y="535519"/>
            <a:ext cx="6309360" cy="194415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02920" y="2677584"/>
            <a:ext cx="6309360" cy="638196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02920" y="9322649"/>
            <a:ext cx="164592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C5123D-F290-C341-8654-3BA8AF323E09}" type="datetimeFigureOut">
              <a:rPr lang="en-US" smtClean="0"/>
              <a:t>4/29/21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423160" y="9322649"/>
            <a:ext cx="246888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166360" y="9322649"/>
            <a:ext cx="164592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886DEE3-3E10-504B-A4A6-7668CE917EF5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06234760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731520" rtl="0" eaLnBrk="1" latinLnBrk="0" hangingPunct="1">
        <a:lnSpc>
          <a:spcPct val="90000"/>
        </a:lnSpc>
        <a:spcBef>
          <a:spcPct val="0"/>
        </a:spcBef>
        <a:buNone/>
        <a:defRPr sz="352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82880" indent="-182880" algn="l" defTabSz="731520" rtl="0" eaLnBrk="1" latinLnBrk="0" hangingPunct="1">
        <a:lnSpc>
          <a:spcPct val="90000"/>
        </a:lnSpc>
        <a:spcBef>
          <a:spcPts val="800"/>
        </a:spcBef>
        <a:buFont typeface="Arial" panose="020B0604020202020204" pitchFamily="34" charset="0"/>
        <a:buChar char="•"/>
        <a:defRPr sz="2240" kern="1200">
          <a:solidFill>
            <a:schemeClr val="tx1"/>
          </a:solidFill>
          <a:latin typeface="+mn-lt"/>
          <a:ea typeface="+mn-ea"/>
          <a:cs typeface="+mn-cs"/>
        </a:defRPr>
      </a:lvl1pPr>
      <a:lvl2pPr marL="54864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92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600" kern="1200">
          <a:solidFill>
            <a:schemeClr val="tx1"/>
          </a:solidFill>
          <a:latin typeface="+mn-lt"/>
          <a:ea typeface="+mn-ea"/>
          <a:cs typeface="+mn-cs"/>
        </a:defRPr>
      </a:lvl3pPr>
      <a:lvl4pPr marL="128016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4pPr>
      <a:lvl5pPr marL="164592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5pPr>
      <a:lvl6pPr marL="201168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6pPr>
      <a:lvl7pPr marL="237744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7pPr>
      <a:lvl8pPr marL="274320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8pPr>
      <a:lvl9pPr marL="310896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1pPr>
      <a:lvl2pPr marL="36576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2pPr>
      <a:lvl3pPr marL="73152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3pPr>
      <a:lvl4pPr marL="109728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4pPr>
      <a:lvl5pPr marL="146304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5pPr>
      <a:lvl6pPr marL="182880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6pPr>
      <a:lvl7pPr marL="219456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7pPr>
      <a:lvl8pPr marL="256032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8pPr>
      <a:lvl9pPr marL="292608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Table 2">
            <a:extLst>
              <a:ext uri="{FF2B5EF4-FFF2-40B4-BE49-F238E27FC236}">
                <a16:creationId xmlns:a16="http://schemas.microsoft.com/office/drawing/2014/main" id="{F37AC17C-A834-AD46-A8F4-7A7BE27D307C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69955199"/>
              </p:ext>
            </p:extLst>
          </p:nvPr>
        </p:nvGraphicFramePr>
        <p:xfrm>
          <a:off x="462379" y="734145"/>
          <a:ext cx="6330998" cy="8423486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486336">
                  <a:extLst>
                    <a:ext uri="{9D8B030D-6E8A-4147-A177-3AD203B41FA5}">
                      <a16:colId xmlns:a16="http://schemas.microsoft.com/office/drawing/2014/main" val="556130888"/>
                    </a:ext>
                  </a:extLst>
                </a:gridCol>
                <a:gridCol w="972672">
                  <a:extLst>
                    <a:ext uri="{9D8B030D-6E8A-4147-A177-3AD203B41FA5}">
                      <a16:colId xmlns:a16="http://schemas.microsoft.com/office/drawing/2014/main" val="1041427849"/>
                    </a:ext>
                  </a:extLst>
                </a:gridCol>
                <a:gridCol w="1891442">
                  <a:extLst>
                    <a:ext uri="{9D8B030D-6E8A-4147-A177-3AD203B41FA5}">
                      <a16:colId xmlns:a16="http://schemas.microsoft.com/office/drawing/2014/main" val="349550496"/>
                    </a:ext>
                  </a:extLst>
                </a:gridCol>
                <a:gridCol w="726955">
                  <a:extLst>
                    <a:ext uri="{9D8B030D-6E8A-4147-A177-3AD203B41FA5}">
                      <a16:colId xmlns:a16="http://schemas.microsoft.com/office/drawing/2014/main" val="2297383424"/>
                    </a:ext>
                  </a:extLst>
                </a:gridCol>
                <a:gridCol w="47483">
                  <a:extLst>
                    <a:ext uri="{9D8B030D-6E8A-4147-A177-3AD203B41FA5}">
                      <a16:colId xmlns:a16="http://schemas.microsoft.com/office/drawing/2014/main" val="3845799265"/>
                    </a:ext>
                  </a:extLst>
                </a:gridCol>
                <a:gridCol w="1634378">
                  <a:extLst>
                    <a:ext uri="{9D8B030D-6E8A-4147-A177-3AD203B41FA5}">
                      <a16:colId xmlns:a16="http://schemas.microsoft.com/office/drawing/2014/main" val="3611027398"/>
                    </a:ext>
                  </a:extLst>
                </a:gridCol>
                <a:gridCol w="571732">
                  <a:extLst>
                    <a:ext uri="{9D8B030D-6E8A-4147-A177-3AD203B41FA5}">
                      <a16:colId xmlns:a16="http://schemas.microsoft.com/office/drawing/2014/main" val="7410241"/>
                    </a:ext>
                  </a:extLst>
                </a:gridCol>
              </a:tblGrid>
              <a:tr h="195596">
                <a:tc gridSpan="7">
                  <a:txBody>
                    <a:bodyPr/>
                    <a:lstStyle/>
                    <a:p>
                      <a:pPr algn="l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able S2</a:t>
                      </a:r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: </a:t>
                      </a:r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QM-MSP primer </a:t>
                      </a:r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nd probe characteristics</a:t>
                      </a:r>
                    </a:p>
                  </a:txBody>
                  <a:tcPr marL="3250" marR="3250" marT="32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 dirty="0"/>
                    </a:p>
                  </a:txBody>
                  <a:tcPr marL="3250" marR="3250" marT="32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l" fontAlgn="b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700005083"/>
                  </a:ext>
                </a:extLst>
              </a:tr>
              <a:tr h="272762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ype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imer/Probe Name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' To 3' Sequence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gridSpan="2">
                  <a:txBody>
                    <a:bodyPr/>
                    <a:lstStyle/>
                    <a:p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rray Target ID</a:t>
                      </a:r>
                      <a:endParaRPr lang="en-US" dirty="0"/>
                    </a:p>
                  </a:txBody>
                  <a:tcPr marL="3250" marR="3250" marT="32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Array Target ID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216" marR="2216" marT="221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imer Location (hg38)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ize (bp)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68517519"/>
                  </a:ext>
                </a:extLst>
              </a:tr>
              <a:tr h="181430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xternal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g054_Ext_F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TTTGGGGAGTYGAAGAA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gridSpan="2">
                  <a:txBody>
                    <a:bodyPr/>
                    <a:lstStyle/>
                    <a:p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g05491001</a:t>
                      </a:r>
                      <a:endParaRPr lang="en-US" dirty="0"/>
                    </a:p>
                  </a:txBody>
                  <a:tcPr marL="3250" marR="3250" marT="32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</a:rPr>
                        <a:t>chr4:61,200,261-61,201,382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216" marR="2216" marT="221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hr4:61,200,754-61,200,888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5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886093011"/>
                  </a:ext>
                </a:extLst>
              </a:tr>
              <a:tr h="137978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xternal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g054_Ext_R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gridSpan="5"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ACCCRTAAAATAAATAATTAACTC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 w="12700" cmpd="sng">
                      <a:noFill/>
                    </a:lnL>
                    <a:lnT w="12700" cmpd="sng">
                      <a:noFill/>
                    </a:lnT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801645359"/>
                  </a:ext>
                </a:extLst>
              </a:tr>
              <a:tr h="137978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arget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g054_FM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gridSpan="4"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GAAGAGATAGCGGCGG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 w="12700" cmpd="sng">
                      <a:noFill/>
                    </a:ln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9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132789355"/>
                  </a:ext>
                </a:extLst>
              </a:tr>
              <a:tr h="137978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arget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g054_RM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gridSpan="4"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ACCGAACCGAACAACTA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 w="12700" cmpd="sng">
                      <a:noFill/>
                    </a:ln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782688128"/>
                  </a:ext>
                </a:extLst>
              </a:tr>
              <a:tr h="137978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arget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g054_M_Probe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gridSpan="4"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GACCCCGAACTCTACGC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 w="12700" cmpd="sng">
                      <a:noFill/>
                    </a:ln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054498112"/>
                  </a:ext>
                </a:extLst>
              </a:tr>
              <a:tr h="137978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arget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g054_FUM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gridSpan="4"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TTGAAGAGATAGTGGTGGTG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 w="12700" cmpd="sng">
                      <a:noFill/>
                    </a:ln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5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76814982"/>
                  </a:ext>
                </a:extLst>
              </a:tr>
              <a:tr h="137978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arget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g054_RUM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gridSpan="4"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CCAACCAAACCAAACAACTA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 w="12700" cmpd="sng">
                      <a:noFill/>
                    </a:ln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357981418"/>
                  </a:ext>
                </a:extLst>
              </a:tr>
              <a:tr h="137978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arget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g054_U_Probe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gridSpan="5"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TCACACAACCCCAAACTCTACAC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 w="12700" cmpd="sng">
                      <a:noFill/>
                    </a:ln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229642243"/>
                  </a:ext>
                </a:extLst>
              </a:tr>
              <a:tr h="218849"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gridSpan="2">
                  <a:txBody>
                    <a:bodyPr/>
                    <a:lstStyle/>
                    <a:p>
                      <a:endParaRPr lang="en-US" dirty="0"/>
                    </a:p>
                  </a:txBody>
                  <a:tcPr marL="3250" marR="3250" marT="32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216" marR="2216" marT="221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100805635"/>
                  </a:ext>
                </a:extLst>
              </a:tr>
              <a:tr h="272762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xternal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i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OCK1</a:t>
                      </a:r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_Ext_F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AGGAAGTTTYGGTTTYGG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gridSpan="2">
                  <a:txBody>
                    <a:bodyPr/>
                    <a:lstStyle/>
                    <a:p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g03242819</a:t>
                      </a:r>
                      <a:endParaRPr lang="en-US" dirty="0"/>
                    </a:p>
                  </a:txBody>
                  <a:tcPr marL="3250" marR="3250" marT="32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cg03242819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216" marR="2216" marT="221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hr10:127,196,134-127,196,313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80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854786978"/>
                  </a:ext>
                </a:extLst>
              </a:tr>
              <a:tr h="137978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xternal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i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OCK1</a:t>
                      </a:r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_Ext_R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gridSpan="4"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CTAACCCAACCRCTACCTC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 w="12700" cmpd="sng">
                      <a:noFill/>
                    </a:lnL>
                    <a:lnT w="12700" cmpd="sng">
                      <a:noFill/>
                    </a:lnT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564517190"/>
                  </a:ext>
                </a:extLst>
              </a:tr>
              <a:tr h="137978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arget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i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OCK1</a:t>
                      </a:r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_FM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gridSpan="4"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GTTGCGCGTTTGTTGTT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 w="12700" cmpd="sng">
                      <a:noFill/>
                    </a:ln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6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413386680"/>
                  </a:ext>
                </a:extLst>
              </a:tr>
              <a:tr h="137978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arget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i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OCK1</a:t>
                      </a:r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_RM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gridSpan="4"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TACGACGCGAAAACCGAC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 w="12700" cmpd="sng">
                      <a:noFill/>
                    </a:ln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10869579"/>
                  </a:ext>
                </a:extLst>
              </a:tr>
              <a:tr h="129982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arget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i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OCK1</a:t>
                      </a:r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_M_Probe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gridSpan="4"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AACCGAACCGACAACGATA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 w="12700" cmpd="sng">
                      <a:noFill/>
                    </a:ln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858785396"/>
                  </a:ext>
                </a:extLst>
              </a:tr>
              <a:tr h="137978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arget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i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OCK1</a:t>
                      </a:r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_FUM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gridSpan="4"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GTTTGTTGTGTGTTTGTTGTTTG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 w="12700" cmpd="sng">
                      <a:noFill/>
                    </a:ln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2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775449893"/>
                  </a:ext>
                </a:extLst>
              </a:tr>
              <a:tr h="137978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arget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i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OCK1</a:t>
                      </a:r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_RUM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gridSpan="5"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ACTACAACACAAAAACCAACCAAAC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 w="12700" cmpd="sng">
                      <a:noFill/>
                    </a:ln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882809418"/>
                  </a:ext>
                </a:extLst>
              </a:tr>
              <a:tr h="170618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arget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i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OCK1</a:t>
                      </a:r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_U_Probe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gridSpan="5"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ACAAAACCAAACCAACAACAAT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 w="12700" cmpd="sng">
                      <a:noFill/>
                    </a:ln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24497201"/>
                  </a:ext>
                </a:extLst>
              </a:tr>
              <a:tr h="218849"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gridSpan="2">
                  <a:txBody>
                    <a:bodyPr/>
                    <a:lstStyle/>
                    <a:p>
                      <a:endParaRPr lang="en-US" dirty="0"/>
                    </a:p>
                  </a:txBody>
                  <a:tcPr marL="3250" marR="3250" marT="32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216" marR="2216" marT="221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573970859"/>
                  </a:ext>
                </a:extLst>
              </a:tr>
              <a:tr h="272762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xternal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i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RIK1</a:t>
                      </a:r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_Ext_F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GTTTTTTAGTGTTGTYGTTA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gridSpan="2">
                  <a:txBody>
                    <a:bodyPr/>
                    <a:lstStyle/>
                    <a:p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g07950000</a:t>
                      </a:r>
                      <a:endParaRPr lang="en-US" dirty="0"/>
                    </a:p>
                  </a:txBody>
                  <a:tcPr marL="3250" marR="3250" marT="32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cg0795000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216" marR="2216" marT="221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hr21:29,939,696-29,939,883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88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6736289"/>
                  </a:ext>
                </a:extLst>
              </a:tr>
              <a:tr h="137978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xternal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i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RIK1</a:t>
                      </a:r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_Ext_R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gridSpan="4"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CCRACTTTTACATCTAACCA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 w="12700" cmpd="sng">
                      <a:noFill/>
                    </a:lnL>
                    <a:lnT w="12700" cmpd="sng">
                      <a:noFill/>
                    </a:lnT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643780612"/>
                  </a:ext>
                </a:extLst>
              </a:tr>
              <a:tr h="137978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arget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i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RIK1</a:t>
                      </a:r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_FM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gridSpan="4"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TGGGTCGTAGATCGC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 w="12700" cmpd="sng">
                      <a:noFill/>
                    </a:ln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1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712479474"/>
                  </a:ext>
                </a:extLst>
              </a:tr>
              <a:tr h="137978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arget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i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RIK1</a:t>
                      </a:r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_RM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gridSpan="4"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GTTCCTACAAATCGTTTCAAC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 w="12700" cmpd="sng">
                      <a:noFill/>
                    </a:ln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367453751"/>
                  </a:ext>
                </a:extLst>
              </a:tr>
              <a:tr h="137978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arget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i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RIK1</a:t>
                      </a:r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_M_Probe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gridSpan="4"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CTCCGAAAACCAAAAAACG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 w="12700" cmpd="sng">
                      <a:noFill/>
                    </a:ln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704135414"/>
                  </a:ext>
                </a:extLst>
              </a:tr>
              <a:tr h="137978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arget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i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RIK1</a:t>
                      </a:r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_FUM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gridSpan="4"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TGGGTTGTAGATTGTGGAG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 w="12700" cmpd="sng">
                      <a:noFill/>
                    </a:ln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4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860910845"/>
                  </a:ext>
                </a:extLst>
              </a:tr>
              <a:tr h="137978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arget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i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RIK1</a:t>
                      </a:r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_RUM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gridSpan="5"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AACATTCCTACAAATCATTTCAACA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 w="12700" cmpd="sng">
                      <a:noFill/>
                    </a:ln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626238760"/>
                  </a:ext>
                </a:extLst>
              </a:tr>
              <a:tr h="137978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arget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i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RIK1</a:t>
                      </a:r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_U_Probe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gridSpan="4"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AACTCCAAAAACCAAAAAACAC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 w="12700" cmpd="sng">
                      <a:noFill/>
                    </a:ln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516650739"/>
                  </a:ext>
                </a:extLst>
              </a:tr>
              <a:tr h="218849"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gridSpan="2">
                  <a:txBody>
                    <a:bodyPr/>
                    <a:lstStyle/>
                    <a:p>
                      <a:endParaRPr lang="en-US" dirty="0"/>
                    </a:p>
                  </a:txBody>
                  <a:tcPr marL="3250" marR="3250" marT="32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216" marR="2216" marT="221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476989573"/>
                  </a:ext>
                </a:extLst>
              </a:tr>
              <a:tr h="272762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xternal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i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CNH7</a:t>
                      </a:r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_Ext_F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TTGYGTATAGGTATGTTGGTTT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gridSpan="2">
                  <a:txBody>
                    <a:bodyPr/>
                    <a:lstStyle/>
                    <a:p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g14781189</a:t>
                      </a:r>
                      <a:endParaRPr lang="en-US" dirty="0"/>
                    </a:p>
                  </a:txBody>
                  <a:tcPr marL="3250" marR="3250" marT="32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chr2:162,838,041-162,839,162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216" marR="2216" marT="221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hr2:162,838,504-162,838,633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0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832891271"/>
                  </a:ext>
                </a:extLst>
              </a:tr>
              <a:tr h="137978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xternal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i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CNH7</a:t>
                      </a:r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_Ext_R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gridSpan="5"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AATACTCTACCACAAAAAACRAC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 w="12700" cmpd="sng">
                      <a:noFill/>
                    </a:lnL>
                    <a:lnT w="12700" cmpd="sng">
                      <a:noFill/>
                    </a:lnT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834194261"/>
                  </a:ext>
                </a:extLst>
              </a:tr>
              <a:tr h="137978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arget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i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CNH7</a:t>
                      </a:r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_FM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gridSpan="4"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CGGTTTTTCGAGGAGCG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 w="12700" cmpd="sng">
                      <a:noFill/>
                    </a:ln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7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397955153"/>
                  </a:ext>
                </a:extLst>
              </a:tr>
              <a:tr h="137978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arget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i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CNH7</a:t>
                      </a:r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_RM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gridSpan="4"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GCTAACCTAAACTCTAACCGA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 w="12700" cmpd="sng">
                      <a:noFill/>
                    </a:ln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996555458"/>
                  </a:ext>
                </a:extLst>
              </a:tr>
              <a:tr h="124751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arget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i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CNH7</a:t>
                      </a:r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_M_Probe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gridSpan="4"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GAAAAAACTCCAAAACTCCG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 w="12700" cmpd="sng">
                      <a:noFill/>
                    </a:ln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31232557"/>
                  </a:ext>
                </a:extLst>
              </a:tr>
              <a:tr h="137978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arget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i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CNH7</a:t>
                      </a:r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_FUM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gridSpan="4"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TGGTTTTTTGAGGAGTGTTT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 w="12700" cmpd="sng">
                      <a:noFill/>
                    </a:ln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2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235381867"/>
                  </a:ext>
                </a:extLst>
              </a:tr>
              <a:tr h="137978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arget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i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CNH7</a:t>
                      </a:r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_RUM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gridSpan="5"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CACACACTAACCTAAACTCTAACCA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 w="12700" cmpd="sng">
                      <a:noFill/>
                    </a:ln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16371640"/>
                  </a:ext>
                </a:extLst>
              </a:tr>
              <a:tr h="98862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arget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i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CNH7</a:t>
                      </a:r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_U_Probe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gridSpan="4"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CAAAAAAACTCCAAAACTCCAA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 w="12700" cmpd="sng">
                      <a:noFill/>
                    </a:ln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616451816"/>
                  </a:ext>
                </a:extLst>
              </a:tr>
              <a:tr h="218849"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gridSpan="2">
                  <a:txBody>
                    <a:bodyPr/>
                    <a:lstStyle/>
                    <a:p>
                      <a:endParaRPr lang="en-US" dirty="0"/>
                    </a:p>
                  </a:txBody>
                  <a:tcPr marL="3250" marR="3250" marT="32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216" marR="2216" marT="221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973449465"/>
                  </a:ext>
                </a:extLst>
              </a:tr>
              <a:tr h="272762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xternal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i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CG3</a:t>
                      </a:r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_Ext_F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l" defTabSz="731520" rtl="0" eaLnBrk="1" fontAlgn="b" latinLnBrk="0" hangingPunct="1"/>
                      <a:r>
                        <a:rPr lang="en-US" sz="900" u="none" strike="noStrike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TTTYGGGGGATTGGAGTA</a:t>
                      </a:r>
                    </a:p>
                  </a:txBody>
                  <a:tcPr marL="3250" marR="3250" marT="32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gridSpan="2">
                  <a:txBody>
                    <a:bodyPr/>
                    <a:lstStyle/>
                    <a:p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g01908954</a:t>
                      </a:r>
                      <a:endParaRPr lang="en-US" dirty="0"/>
                    </a:p>
                  </a:txBody>
                  <a:tcPr marL="3250" marR="3250" marT="32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cg01908954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216" marR="2216" marT="221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hr15:51,681,359-51,681,526</a:t>
                      </a:r>
                      <a:endParaRPr lang="en-US" sz="900" b="0" i="0" u="none" strike="noStrike" dirty="0">
                        <a:solidFill>
                          <a:srgbClr val="495057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8</a:t>
                      </a:r>
                      <a:endParaRPr lang="en-US" sz="900" b="0" i="0" u="none" strike="noStrike" dirty="0">
                        <a:solidFill>
                          <a:srgbClr val="495057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31736885"/>
                  </a:ext>
                </a:extLst>
              </a:tr>
              <a:tr h="137978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xternal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i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CG3</a:t>
                      </a:r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_Ext_R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gridSpan="5"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CCTATAAATACTAAAATTCCTATAAC 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 w="12700" cmpd="sng">
                      <a:noFill/>
                    </a:lnL>
                    <a:lnT w="12700" cmpd="sng">
                      <a:noFill/>
                    </a:lnT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186386168"/>
                  </a:ext>
                </a:extLst>
              </a:tr>
              <a:tr h="137978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arget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i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CG3</a:t>
                      </a:r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_FM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gridSpan="4"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GTTGGAGTTATCGACGTTAT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 w="12700" cmpd="sng">
                      <a:noFill/>
                    </a:ln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6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312680397"/>
                  </a:ext>
                </a:extLst>
              </a:tr>
              <a:tr h="137978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arget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i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CG3</a:t>
                      </a:r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_RM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gridSpan="4"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AAACGTAACTTTACTCTCGCT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 w="12700" cmpd="sng">
                      <a:noFill/>
                    </a:ln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782345034"/>
                  </a:ext>
                </a:extLst>
              </a:tr>
              <a:tr h="137978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arget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i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CG3</a:t>
                      </a:r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_M_Probe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gridSpan="4"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ACGCATACTCCATACACGC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 w="12700" cmpd="sng">
                      <a:noFill/>
                    </a:ln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628920806"/>
                  </a:ext>
                </a:extLst>
              </a:tr>
              <a:tr h="137978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arget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i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CG3</a:t>
                      </a:r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_FUM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gridSpan="4"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GTTGGAGTTATTGATGTTATT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 w="12700" cmpd="sng">
                      <a:noFill/>
                    </a:ln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6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019072625"/>
                  </a:ext>
                </a:extLst>
              </a:tr>
              <a:tr h="137978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arget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i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CG3</a:t>
                      </a:r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_RUM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gridSpan="5"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AAACATAACTTTACTCTCACTCC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 w="12700" cmpd="sng">
                      <a:noFill/>
                    </a:ln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329846701"/>
                  </a:ext>
                </a:extLst>
              </a:tr>
              <a:tr h="137978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arget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i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CG3</a:t>
                      </a:r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_U_Probe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gridSpan="5"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ACACATACTCCATACACACCAAA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 w="12700" cmpd="sng">
                      <a:noFill/>
                    </a:ln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063682958"/>
                  </a:ext>
                </a:extLst>
              </a:tr>
              <a:tr h="137978"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gridSpan="2">
                  <a:txBody>
                    <a:bodyPr/>
                    <a:lstStyle/>
                    <a:p>
                      <a:pPr algn="l" fontAlgn="b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613779065"/>
                  </a:ext>
                </a:extLst>
              </a:tr>
              <a:tr h="137978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xternal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i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CTB</a:t>
                      </a:r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_Ext_F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gridSpan="3">
                  <a:txBody>
                    <a:bodyPr/>
                    <a:lstStyle/>
                    <a:p>
                      <a:pPr algn="l" fontAlgn="b"/>
                      <a:r>
                        <a:rPr lang="en-US" sz="90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GGGAGATAGTTTTTATTTATTTAGGA 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 w="12700" cmpd="sng">
                      <a:noFill/>
                    </a:lnL>
                    <a:lnT w="12700" cmpd="sng">
                      <a:noFill/>
                    </a:lnT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hr7:5,528,261-5,528,395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5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819506819"/>
                  </a:ext>
                </a:extLst>
              </a:tr>
              <a:tr h="137978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xternal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i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CTB</a:t>
                      </a:r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_Ext_R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gridSpan="5">
                  <a:txBody>
                    <a:bodyPr/>
                    <a:lstStyle/>
                    <a:p>
                      <a:pPr algn="l" fontAlgn="b"/>
                      <a:r>
                        <a:rPr lang="en-US" sz="90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ACTACTTCCAACTCCTCCCTA </a:t>
                      </a:r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 w="12700" cmpd="sng">
                      <a:noFill/>
                    </a:ln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565277908"/>
                  </a:ext>
                </a:extLst>
              </a:tr>
              <a:tr h="137978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arget</a:t>
                      </a:r>
                    </a:p>
                  </a:txBody>
                  <a:tcPr marL="3250" marR="3250" marT="32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73152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i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CTB</a:t>
                      </a:r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_Intern_R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gridSpan="4">
                  <a:txBody>
                    <a:bodyPr/>
                    <a:lstStyle/>
                    <a:p>
                      <a:pPr algn="l" fontAlgn="b"/>
                      <a:r>
                        <a:rPr lang="en-US" sz="90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GTTTTTATTTATTTAGGAAGGAAG</a:t>
                      </a:r>
                      <a:r>
                        <a:rPr lang="en-US" sz="9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644546"/>
                  </a:ext>
                </a:extLst>
              </a:tr>
              <a:tr h="137978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arget</a:t>
                      </a:r>
                    </a:p>
                  </a:txBody>
                  <a:tcPr marL="3250" marR="3250" marT="32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73152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i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CTB</a:t>
                      </a:r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_Intern_R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gridSpan="4">
                  <a:txBody>
                    <a:bodyPr/>
                    <a:lstStyle/>
                    <a:p>
                      <a:pPr algn="l" fontAlgn="b"/>
                      <a:r>
                        <a:rPr lang="en-US" sz="90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AAATCATCACCATTAACAATAAAC 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44100155"/>
                  </a:ext>
                </a:extLst>
              </a:tr>
              <a:tr h="137978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arget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i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CTB</a:t>
                      </a:r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_Probe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gridSpan="4"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TACCCTAAAACACTCTTCC 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250" marR="3250" marT="325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904793210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35319440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4277</TotalTime>
  <Words>331</Words>
  <Application>Microsoft Macintosh PowerPoint</Application>
  <PresentationFormat>Custom</PresentationFormat>
  <Paragraphs>16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radley Downs</dc:creator>
  <cp:lastModifiedBy>Bradley Downs</cp:lastModifiedBy>
  <cp:revision>450</cp:revision>
  <cp:lastPrinted>2021-03-15T15:34:39Z</cp:lastPrinted>
  <dcterms:created xsi:type="dcterms:W3CDTF">2019-09-14T17:51:09Z</dcterms:created>
  <dcterms:modified xsi:type="dcterms:W3CDTF">2021-04-29T19:03:37Z</dcterms:modified>
</cp:coreProperties>
</file>